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P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3B641A-12A2-4D43-B9FD-1DDB7B26A612}" v="3" dt="2021-08-15T00:45:29.82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49" autoAdjust="0"/>
  </p:normalViewPr>
  <p:slideViewPr>
    <p:cSldViewPr snapToGrid="0">
      <p:cViewPr varScale="1">
        <p:scale>
          <a:sx n="72" d="100"/>
          <a:sy n="72" d="100"/>
        </p:scale>
        <p:origin x="6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r. Muhammad Murtaza khan" userId="e452141b0539258f" providerId="LiveId" clId="{0D3B641A-12A2-4D43-B9FD-1DDB7B26A612}"/>
    <pc:docChg chg="undo custSel addSld modSld">
      <pc:chgData name="Mr. Muhammad Murtaza khan" userId="e452141b0539258f" providerId="LiveId" clId="{0D3B641A-12A2-4D43-B9FD-1DDB7B26A612}" dt="2021-08-15T00:52:34.143" v="31" actId="113"/>
      <pc:docMkLst>
        <pc:docMk/>
      </pc:docMkLst>
      <pc:sldChg chg="addSp delSp modSp new mod modClrScheme chgLayout">
        <pc:chgData name="Mr. Muhammad Murtaza khan" userId="e452141b0539258f" providerId="LiveId" clId="{0D3B641A-12A2-4D43-B9FD-1DDB7B26A612}" dt="2021-08-15T00:52:34.143" v="31" actId="113"/>
        <pc:sldMkLst>
          <pc:docMk/>
          <pc:sldMk cId="2381820496" sldId="256"/>
        </pc:sldMkLst>
        <pc:spChg chg="del">
          <ac:chgData name="Mr. Muhammad Murtaza khan" userId="e452141b0539258f" providerId="LiveId" clId="{0D3B641A-12A2-4D43-B9FD-1DDB7B26A612}" dt="2021-08-15T00:42:17.577" v="1" actId="700"/>
          <ac:spMkLst>
            <pc:docMk/>
            <pc:sldMk cId="2381820496" sldId="256"/>
            <ac:spMk id="2" creationId="{DD463E27-EF62-4F6F-86C6-A78009FE523F}"/>
          </ac:spMkLst>
        </pc:spChg>
        <pc:spChg chg="del">
          <ac:chgData name="Mr. Muhammad Murtaza khan" userId="e452141b0539258f" providerId="LiveId" clId="{0D3B641A-12A2-4D43-B9FD-1DDB7B26A612}" dt="2021-08-15T00:42:17.577" v="1" actId="700"/>
          <ac:spMkLst>
            <pc:docMk/>
            <pc:sldMk cId="2381820496" sldId="256"/>
            <ac:spMk id="3" creationId="{5C328DA2-3A30-46B0-A5E6-9B9B8ED52316}"/>
          </ac:spMkLst>
        </pc:spChg>
        <pc:graphicFrameChg chg="add del mod modGraphic">
          <ac:chgData name="Mr. Muhammad Murtaza khan" userId="e452141b0539258f" providerId="LiveId" clId="{0D3B641A-12A2-4D43-B9FD-1DDB7B26A612}" dt="2021-08-15T00:42:45.300" v="5"/>
          <ac:graphicFrameMkLst>
            <pc:docMk/>
            <pc:sldMk cId="2381820496" sldId="256"/>
            <ac:graphicFrameMk id="4" creationId="{BB6F09F9-3E94-4611-A411-230CB69E9328}"/>
          </ac:graphicFrameMkLst>
        </pc:graphicFrameChg>
        <pc:graphicFrameChg chg="add mod modGraphic">
          <ac:chgData name="Mr. Muhammad Murtaza khan" userId="e452141b0539258f" providerId="LiveId" clId="{0D3B641A-12A2-4D43-B9FD-1DDB7B26A612}" dt="2021-08-15T00:52:34.143" v="31" actId="113"/>
          <ac:graphicFrameMkLst>
            <pc:docMk/>
            <pc:sldMk cId="2381820496" sldId="256"/>
            <ac:graphicFrameMk id="5" creationId="{990950EE-5A2D-4377-B291-DCB9F487ED2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BD64A1-C2A7-4DDB-A54B-854971E7F79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0E61F2E-9950-4A7B-A49E-29C1F373C2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79CF29-25C8-4145-ACCD-0BDF9C2FD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4E63CC-EF88-4037-A699-956D9367B5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C6449D-DD48-4ADC-8CAE-18717A2CB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239185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9F5D9B-61F7-40EC-9AEE-609CAB35B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B5D8EC-D171-4435-BEF6-13E9A53178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F48251-FC36-4926-B35D-DE4902F60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11629-7062-407B-9584-95674F00C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88DE35-BB7C-49E6-9B40-45CF035B7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144832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B9D83E-ED50-4E34-A3E8-41077625A2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FEAC43-C896-41FA-9BC7-27B62FF4E3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1561BD-E49D-42CE-AA53-8CE98F6F2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51DE61-B377-409A-940C-51A87316F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32ACE7-8CA0-49E0-BFA6-64A6BB784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7053835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22947-2F67-45D2-B852-24C6EB1327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9C686-C4C6-4435-991A-D13D233E32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579A19-80F6-4BC8-BFB2-A35C40DFF2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A46D61-303E-4EE7-85D2-98C1C39BA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0F30E2-BDB5-4CAC-B9AE-B438FFD7E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58337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C77E62-A298-41E3-92CF-166DCBD9E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8B6BAB-0F88-46DD-9705-59451909D5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4CE649-ED95-46EE-9981-6D8CB434B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9919F5-A68B-43FB-8D47-946867080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A7BD1C-30CB-4380-A9EF-0AF858702C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802835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093596-266A-4230-8AB2-FE3470783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94B94E-338F-4AC4-892A-C311DE6D94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816690E-4EBC-4860-971A-C3BAEC5849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53B6AE-B399-43E5-930C-846B07036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2EADCE-BC58-4584-93E4-5E3B4AAC1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8DB06D-CD8A-45A9-ADAF-04187FB3C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891290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107BE1-7C54-4296-A555-10059647B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78F92A-E815-40E9-AECD-7E2A5A9FFF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DBE42-3474-4D36-AAE6-242CA19D22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B9E00C-C011-4BDB-96A9-A5439FA33B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F9A10E-6346-40D6-815D-98360988762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7C2CDA-C0E1-47C8-BF42-704AEA541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BA2871-56D9-4C7B-AF73-2E3CA5C13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C8DBEA5-5F7E-471D-B7F7-E69CCA51D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619288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69BB6B-BDE0-47D4-9CE9-A559CFB9C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182005-7433-4E48-9C08-F487F67C7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F40E74-5D4D-47B8-B91F-49FEACC28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806BDB3-24BE-4510-8427-12B2F1014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469635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5AB4F5-8469-467B-AD5F-69AC3EDBD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2CEDF4-4E3F-45F9-B4FA-030D6F9C8D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2C326A-120E-4A90-9252-DA0B94C5E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1384080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BE4892-A551-46B3-8205-D53BDBFAF7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B96263-906B-431A-87AE-44A066240C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2ED72C-0037-439E-9601-3F7860BB57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EF0627-A785-4B3A-9074-B48CF6495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2D404F-8598-464A-99D9-ED3846A5A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ADCD0C-5E8A-4D44-A3E8-BE78499232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358917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4A03F1-E652-46D8-906D-E4301828C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B02D18-56D3-40E7-91D3-305F36EF1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P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4CC225-93C4-41BA-9782-5A7D695BB4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6240B3-6E0F-40AE-8967-F7FDAE6A9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101CCE-6EDF-4490-8056-65B193BBD1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0BDC33-621B-4D12-B95D-E36033BD2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6738423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9592DE-73A6-4ADB-9245-5FC78387E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P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68E773-7167-44B8-9A90-0B541E37E9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P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1E1E0F-BC96-4931-8D84-34F2AADA21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C006CC-12CE-4F5B-83DA-A1D356A43F71}" type="datetimeFigureOut">
              <a:rPr lang="en-PK" smtClean="0"/>
              <a:t>15/08/2021</a:t>
            </a:fld>
            <a:endParaRPr lang="en-P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CF9A7C-8405-45BE-9966-523514E000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EDF018-AE09-4CDA-AD83-B0B4FFF5E6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68732-C295-40C8-B4DA-10800C3E9477}" type="slidenum">
              <a:rPr lang="en-PK" smtClean="0"/>
              <a:t>‹#›</a:t>
            </a:fld>
            <a:endParaRPr lang="en-PK"/>
          </a:p>
        </p:txBody>
      </p:sp>
    </p:spTree>
    <p:extLst>
      <p:ext uri="{BB962C8B-B14F-4D97-AF65-F5344CB8AC3E}">
        <p14:creationId xmlns:p14="http://schemas.microsoft.com/office/powerpoint/2010/main" val="2507856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P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90950EE-5A2D-4377-B291-DCB9F487ED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8741829"/>
              </p:ext>
            </p:extLst>
          </p:nvPr>
        </p:nvGraphicFramePr>
        <p:xfrm>
          <a:off x="0" y="-1"/>
          <a:ext cx="12192000" cy="6938694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862288">
                  <a:extLst>
                    <a:ext uri="{9D8B030D-6E8A-4147-A177-3AD203B41FA5}">
                      <a16:colId xmlns:a16="http://schemas.microsoft.com/office/drawing/2014/main" val="1782782233"/>
                    </a:ext>
                  </a:extLst>
                </a:gridCol>
                <a:gridCol w="2789313">
                  <a:extLst>
                    <a:ext uri="{9D8B030D-6E8A-4147-A177-3AD203B41FA5}">
                      <a16:colId xmlns:a16="http://schemas.microsoft.com/office/drawing/2014/main" val="1023464067"/>
                    </a:ext>
                  </a:extLst>
                </a:gridCol>
                <a:gridCol w="1759567">
                  <a:extLst>
                    <a:ext uri="{9D8B030D-6E8A-4147-A177-3AD203B41FA5}">
                      <a16:colId xmlns:a16="http://schemas.microsoft.com/office/drawing/2014/main" val="658216895"/>
                    </a:ext>
                  </a:extLst>
                </a:gridCol>
                <a:gridCol w="1359665">
                  <a:extLst>
                    <a:ext uri="{9D8B030D-6E8A-4147-A177-3AD203B41FA5}">
                      <a16:colId xmlns:a16="http://schemas.microsoft.com/office/drawing/2014/main" val="3351683688"/>
                    </a:ext>
                  </a:extLst>
                </a:gridCol>
                <a:gridCol w="1942023">
                  <a:extLst>
                    <a:ext uri="{9D8B030D-6E8A-4147-A177-3AD203B41FA5}">
                      <a16:colId xmlns:a16="http://schemas.microsoft.com/office/drawing/2014/main" val="2007072565"/>
                    </a:ext>
                  </a:extLst>
                </a:gridCol>
                <a:gridCol w="1769564">
                  <a:extLst>
                    <a:ext uri="{9D8B030D-6E8A-4147-A177-3AD203B41FA5}">
                      <a16:colId xmlns:a16="http://schemas.microsoft.com/office/drawing/2014/main" val="3948200054"/>
                    </a:ext>
                  </a:extLst>
                </a:gridCol>
                <a:gridCol w="1709580">
                  <a:extLst>
                    <a:ext uri="{9D8B030D-6E8A-4147-A177-3AD203B41FA5}">
                      <a16:colId xmlns:a16="http://schemas.microsoft.com/office/drawing/2014/main" val="1914439936"/>
                    </a:ext>
                  </a:extLst>
                </a:gridCol>
              </a:tblGrid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Histor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Outcom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Acute injury last 3 months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Suspicion of meniscal injur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>
                          <a:effectLst/>
                        </a:rPr>
                        <a:t>X ray done before MRI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MRI contraindications (See table  3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b="1" u="none" strike="noStrike" dirty="0">
                          <a:effectLst/>
                        </a:rPr>
                        <a:t>Guidelines followe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25816229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743648095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,6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14907253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409638033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477664984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672131748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594365367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873116838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006946716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77082371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23945664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4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339629141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021772409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,6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884819778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u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085652481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u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12508212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02547570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567452987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4,5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68904427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964936927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6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11397732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555437395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706039454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4,5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053441125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18560238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5,6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09520706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u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639279188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31517641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48813804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4,5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43193015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52595690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u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01756046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90760060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265526375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4,5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14550742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Traum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47186852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4,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449457254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660963359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rthroscop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180846687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3,4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17776944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328707476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381129060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5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111508545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,,8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540603933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7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41584228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804785910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Ye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581264637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4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09686469"/>
                  </a:ext>
                </a:extLst>
              </a:tr>
              <a:tr h="14160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Degener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Conservativ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No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PK" sz="900" u="none" strike="noStrike">
                          <a:effectLst/>
                        </a:rPr>
                        <a:t>1,3,4,6</a:t>
                      </a:r>
                      <a:endParaRPr lang="en-PK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No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446" marR="4446" marT="4446" marB="0" anchor="b"/>
                </a:tc>
                <a:extLst>
                  <a:ext uri="{0D108BD9-81ED-4DB2-BD59-A6C34878D82A}">
                    <a16:rowId xmlns:a16="http://schemas.microsoft.com/office/drawing/2014/main" val="236801706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1820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63</Words>
  <Application>Microsoft Office PowerPoint</Application>
  <PresentationFormat>Widescreen</PresentationFormat>
  <Paragraphs>3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r. Muhammad Murtaza khan</dc:creator>
  <cp:lastModifiedBy>Mr. Muhammad Murtaza khan</cp:lastModifiedBy>
  <cp:revision>1</cp:revision>
  <dcterms:created xsi:type="dcterms:W3CDTF">2021-08-15T00:42:07Z</dcterms:created>
  <dcterms:modified xsi:type="dcterms:W3CDTF">2021-08-15T00:52:37Z</dcterms:modified>
</cp:coreProperties>
</file>